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1" d="100"/>
          <a:sy n="101" d="100"/>
        </p:scale>
        <p:origin x="-2024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56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02500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2992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18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0192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468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692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605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228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2031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20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680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09600" y="609600"/>
            <a:ext cx="8226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. 1D</a:t>
            </a:r>
            <a:endParaRPr lang="en-US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22162825"/>
              </p:ext>
            </p:extLst>
          </p:nvPr>
        </p:nvGraphicFramePr>
        <p:xfrm>
          <a:off x="228600" y="2895600"/>
          <a:ext cx="8367461" cy="995215"/>
        </p:xfrm>
        <a:graphic>
          <a:graphicData uri="http://schemas.openxmlformats.org/drawingml/2006/table">
            <a:tbl>
              <a:tblPr/>
              <a:tblGrid>
                <a:gridCol w="621103">
                  <a:extLst>
                    <a:ext uri="{9D8B030D-6E8A-4147-A177-3AD203B41FA5}">
                      <a16:colId xmlns:a16="http://schemas.microsoft.com/office/drawing/2014/main" xmlns="" val="3826035480"/>
                    </a:ext>
                  </a:extLst>
                </a:gridCol>
                <a:gridCol w="500331">
                  <a:extLst>
                    <a:ext uri="{9D8B030D-6E8A-4147-A177-3AD203B41FA5}">
                      <a16:colId xmlns:a16="http://schemas.microsoft.com/office/drawing/2014/main" xmlns="" val="11827888"/>
                    </a:ext>
                  </a:extLst>
                </a:gridCol>
                <a:gridCol w="433312">
                  <a:extLst>
                    <a:ext uri="{9D8B030D-6E8A-4147-A177-3AD203B41FA5}">
                      <a16:colId xmlns:a16="http://schemas.microsoft.com/office/drawing/2014/main" xmlns="" val="3420961634"/>
                    </a:ext>
                  </a:extLst>
                </a:gridCol>
                <a:gridCol w="524055">
                  <a:extLst>
                    <a:ext uri="{9D8B030D-6E8A-4147-A177-3AD203B41FA5}">
                      <a16:colId xmlns:a16="http://schemas.microsoft.com/office/drawing/2014/main" xmlns="" val="556356960"/>
                    </a:ext>
                  </a:extLst>
                </a:gridCol>
                <a:gridCol w="524055">
                  <a:extLst>
                    <a:ext uri="{9D8B030D-6E8A-4147-A177-3AD203B41FA5}">
                      <a16:colId xmlns:a16="http://schemas.microsoft.com/office/drawing/2014/main" xmlns="" val="4044412123"/>
                    </a:ext>
                  </a:extLst>
                </a:gridCol>
                <a:gridCol w="524055">
                  <a:extLst>
                    <a:ext uri="{9D8B030D-6E8A-4147-A177-3AD203B41FA5}">
                      <a16:colId xmlns:a16="http://schemas.microsoft.com/office/drawing/2014/main" xmlns="" val="1830372599"/>
                    </a:ext>
                  </a:extLst>
                </a:gridCol>
                <a:gridCol w="524055">
                  <a:extLst>
                    <a:ext uri="{9D8B030D-6E8A-4147-A177-3AD203B41FA5}">
                      <a16:colId xmlns:a16="http://schemas.microsoft.com/office/drawing/2014/main" xmlns="" val="4087905945"/>
                    </a:ext>
                  </a:extLst>
                </a:gridCol>
                <a:gridCol w="524055">
                  <a:extLst>
                    <a:ext uri="{9D8B030D-6E8A-4147-A177-3AD203B41FA5}">
                      <a16:colId xmlns:a16="http://schemas.microsoft.com/office/drawing/2014/main" xmlns="" val="4274623609"/>
                    </a:ext>
                  </a:extLst>
                </a:gridCol>
                <a:gridCol w="524055">
                  <a:extLst>
                    <a:ext uri="{9D8B030D-6E8A-4147-A177-3AD203B41FA5}">
                      <a16:colId xmlns:a16="http://schemas.microsoft.com/office/drawing/2014/main" xmlns="" val="1129572946"/>
                    </a:ext>
                  </a:extLst>
                </a:gridCol>
                <a:gridCol w="524055">
                  <a:extLst>
                    <a:ext uri="{9D8B030D-6E8A-4147-A177-3AD203B41FA5}">
                      <a16:colId xmlns:a16="http://schemas.microsoft.com/office/drawing/2014/main" xmlns="" val="3194898720"/>
                    </a:ext>
                  </a:extLst>
                </a:gridCol>
                <a:gridCol w="524055">
                  <a:extLst>
                    <a:ext uri="{9D8B030D-6E8A-4147-A177-3AD203B41FA5}">
                      <a16:colId xmlns:a16="http://schemas.microsoft.com/office/drawing/2014/main" xmlns="" val="323735787"/>
                    </a:ext>
                  </a:extLst>
                </a:gridCol>
                <a:gridCol w="524055">
                  <a:extLst>
                    <a:ext uri="{9D8B030D-6E8A-4147-A177-3AD203B41FA5}">
                      <a16:colId xmlns:a16="http://schemas.microsoft.com/office/drawing/2014/main" xmlns="" val="4113820565"/>
                    </a:ext>
                  </a:extLst>
                </a:gridCol>
                <a:gridCol w="524055">
                  <a:extLst>
                    <a:ext uri="{9D8B030D-6E8A-4147-A177-3AD203B41FA5}">
                      <a16:colId xmlns:a16="http://schemas.microsoft.com/office/drawing/2014/main" xmlns="" val="2098481841"/>
                    </a:ext>
                  </a:extLst>
                </a:gridCol>
                <a:gridCol w="524055">
                  <a:extLst>
                    <a:ext uri="{9D8B030D-6E8A-4147-A177-3AD203B41FA5}">
                      <a16:colId xmlns:a16="http://schemas.microsoft.com/office/drawing/2014/main" xmlns="" val="3714657302"/>
                    </a:ext>
                  </a:extLst>
                </a:gridCol>
                <a:gridCol w="524055">
                  <a:extLst>
                    <a:ext uri="{9D8B030D-6E8A-4147-A177-3AD203B41FA5}">
                      <a16:colId xmlns:a16="http://schemas.microsoft.com/office/drawing/2014/main" xmlns="" val="257796099"/>
                    </a:ext>
                  </a:extLst>
                </a:gridCol>
                <a:gridCol w="524055">
                  <a:extLst>
                    <a:ext uri="{9D8B030D-6E8A-4147-A177-3AD203B41FA5}">
                      <a16:colId xmlns:a16="http://schemas.microsoft.com/office/drawing/2014/main" xmlns="" val="1420295295"/>
                    </a:ext>
                  </a:extLst>
                </a:gridCol>
              </a:tblGrid>
              <a:tr h="11115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Lnc-ECE1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9982669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2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08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011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228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6239055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5.7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195814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41.2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9298274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14641998"/>
                  </a:ext>
                </a:extLst>
              </a:tr>
              <a:tr h="215766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Lnc-GATA2-AS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9971385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4098221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8.366577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1995414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0.61244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1496056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44.32758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04573692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18.68584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1007762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20936449"/>
                  </a:ext>
                </a:extLst>
              </a:tr>
              <a:tr h="215766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Lnc-ESAM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9992062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024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2963312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3527387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142.646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02973226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80.08491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007692121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12.29519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1932657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33615192"/>
                  </a:ext>
                </a:extLst>
              </a:tr>
              <a:tr h="215766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Lnc-ROBO4-AS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1.001298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1391815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0919610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1465332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29.77504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02220414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40.19518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02768262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1.327234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0764125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64769835"/>
                  </a:ext>
                </a:extLst>
              </a:tr>
              <a:tr h="11115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Lnc-FLI1-AS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996848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1.09446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9070526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1.137727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3.07079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1789324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1.22819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4617147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60.5559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05081489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26090534"/>
                  </a:ext>
                </a:extLst>
              </a:tr>
              <a:tr h="11115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LncEGFL7-AS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7.007026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1412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237.3611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107047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567.8321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167922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820.6708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0.1322512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8" marR="6538" marT="65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33109067"/>
                  </a:ext>
                </a:extLst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02777040"/>
              </p:ext>
            </p:extLst>
          </p:nvPr>
        </p:nvGraphicFramePr>
        <p:xfrm>
          <a:off x="609605" y="2427693"/>
          <a:ext cx="8229600" cy="272317"/>
        </p:xfrm>
        <a:graphic>
          <a:graphicData uri="http://schemas.openxmlformats.org/drawingml/2006/table">
            <a:tbl>
              <a:tblPr/>
              <a:tblGrid>
                <a:gridCol w="548640">
                  <a:extLst>
                    <a:ext uri="{9D8B030D-6E8A-4147-A177-3AD203B41FA5}">
                      <a16:colId xmlns:a16="http://schemas.microsoft.com/office/drawing/2014/main" xmlns="" val="986073649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xmlns="" val="3994098789"/>
                    </a:ext>
                  </a:extLst>
                </a:gridCol>
                <a:gridCol w="464823">
                  <a:extLst>
                    <a:ext uri="{9D8B030D-6E8A-4147-A177-3AD203B41FA5}">
                      <a16:colId xmlns:a16="http://schemas.microsoft.com/office/drawing/2014/main" xmlns="" val="4227341900"/>
                    </a:ext>
                  </a:extLst>
                </a:gridCol>
                <a:gridCol w="632457">
                  <a:extLst>
                    <a:ext uri="{9D8B030D-6E8A-4147-A177-3AD203B41FA5}">
                      <a16:colId xmlns:a16="http://schemas.microsoft.com/office/drawing/2014/main" xmlns="" val="1214960727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xmlns="" val="2192621950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xmlns="" val="46555335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xmlns="" val="4243900439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xmlns="" val="4285804973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xmlns="" val="1371775372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xmlns="" val="3555938950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xmlns="" val="924798627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xmlns="" val="1216579341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xmlns="" val="3330577081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xmlns="" val="1052605533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xmlns="" val="495700379"/>
                    </a:ext>
                  </a:extLst>
                </a:gridCol>
              </a:tblGrid>
              <a:tr h="152400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ARPE-19</a:t>
                      </a:r>
                    </a:p>
                  </a:txBody>
                  <a:tcPr marL="7054" marR="7054" marT="70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HDEF</a:t>
                      </a:r>
                    </a:p>
                  </a:txBody>
                  <a:tcPr marL="7054" marR="7054" marT="70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HUVEC</a:t>
                      </a:r>
                    </a:p>
                  </a:txBody>
                  <a:tcPr marL="7054" marR="7054" marT="70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HREC</a:t>
                      </a:r>
                    </a:p>
                  </a:txBody>
                  <a:tcPr marL="7054" marR="7054" marT="70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HCEC</a:t>
                      </a:r>
                    </a:p>
                  </a:txBody>
                  <a:tcPr marL="7054" marR="7054" marT="70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408740291"/>
                  </a:ext>
                </a:extLst>
              </a:tr>
              <a:tr h="119917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 smtClean="0">
                          <a:effectLst/>
                          <a:latin typeface="Arial" panose="020B0604020202020204" pitchFamily="34" charset="0"/>
                        </a:rPr>
                        <a:t>mean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4" marR="7054" marT="70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 err="1" smtClean="0">
                          <a:effectLst/>
                          <a:latin typeface="Arial" panose="020B0604020202020204" pitchFamily="34" charset="0"/>
                        </a:rPr>
                        <a:t>sd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4" marR="7054" marT="70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 smtClean="0">
                          <a:effectLst/>
                          <a:latin typeface="Arial" panose="020B0604020202020204" pitchFamily="34" charset="0"/>
                        </a:rPr>
                        <a:t>n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4" marR="7054" marT="70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 smtClean="0">
                          <a:effectLst/>
                          <a:latin typeface="Arial" panose="020B0604020202020204" pitchFamily="34" charset="0"/>
                        </a:rPr>
                        <a:t>mean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4" marR="7054" marT="70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 err="1" smtClean="0">
                          <a:effectLst/>
                          <a:latin typeface="Arial" panose="020B0604020202020204" pitchFamily="34" charset="0"/>
                        </a:rPr>
                        <a:t>sd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4" marR="7054" marT="70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 smtClean="0">
                          <a:effectLst/>
                          <a:latin typeface="Arial" panose="020B0604020202020204" pitchFamily="34" charset="0"/>
                        </a:rPr>
                        <a:t>n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4" marR="7054" marT="70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 smtClean="0">
                          <a:effectLst/>
                          <a:latin typeface="Arial" panose="020B0604020202020204" pitchFamily="34" charset="0"/>
                        </a:rPr>
                        <a:t>mean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4" marR="7054" marT="70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 err="1" smtClean="0">
                          <a:effectLst/>
                          <a:latin typeface="Arial" panose="020B0604020202020204" pitchFamily="34" charset="0"/>
                        </a:rPr>
                        <a:t>sd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4" marR="7054" marT="70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 smtClean="0">
                          <a:effectLst/>
                          <a:latin typeface="Arial" panose="020B0604020202020204" pitchFamily="34" charset="0"/>
                        </a:rPr>
                        <a:t>n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4" marR="7054" marT="70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 smtClean="0">
                          <a:effectLst/>
                          <a:latin typeface="Arial" panose="020B0604020202020204" pitchFamily="34" charset="0"/>
                        </a:rPr>
                        <a:t>mean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4" marR="7054" marT="70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 err="1" smtClean="0">
                          <a:effectLst/>
                          <a:latin typeface="Arial" panose="020B0604020202020204" pitchFamily="34" charset="0"/>
                        </a:rPr>
                        <a:t>sd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4" marR="7054" marT="70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 smtClean="0">
                          <a:effectLst/>
                          <a:latin typeface="Arial" panose="020B0604020202020204" pitchFamily="34" charset="0"/>
                        </a:rPr>
                        <a:t>n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4" marR="7054" marT="70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 smtClean="0">
                          <a:effectLst/>
                          <a:latin typeface="Arial" panose="020B0604020202020204" pitchFamily="34" charset="0"/>
                        </a:rPr>
                        <a:t>mean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4" marR="7054" marT="70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 err="1" smtClean="0">
                          <a:effectLst/>
                          <a:latin typeface="Arial" panose="020B0604020202020204" pitchFamily="34" charset="0"/>
                        </a:rPr>
                        <a:t>sd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4" marR="7054" marT="70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 smtClean="0">
                          <a:effectLst/>
                          <a:latin typeface="Arial" panose="020B0604020202020204" pitchFamily="34" charset="0"/>
                        </a:rPr>
                        <a:t>n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4" marR="7054" marT="70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5306440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346962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39</Words>
  <Application>Microsoft Macintosh PowerPoint</Application>
  <PresentationFormat>On-screen Show (4:3)</PresentationFormat>
  <Paragraphs>1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na</dc:creator>
  <cp:lastModifiedBy>Susanna</cp:lastModifiedBy>
  <cp:revision>1</cp:revision>
  <dcterms:created xsi:type="dcterms:W3CDTF">2018-12-03T10:45:52Z</dcterms:created>
  <dcterms:modified xsi:type="dcterms:W3CDTF">2018-12-03T10:47:44Z</dcterms:modified>
</cp:coreProperties>
</file>